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599988" cy="125999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978968-55A0-4737-9F01-54C6C92073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0360" y="2940120"/>
            <a:ext cx="1133928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0360" y="7283520"/>
            <a:ext cx="1133928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7BDBD-F088-4C77-BB48-534ED99CF4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0360" y="29401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441120" y="29401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0360" y="72835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441120" y="72835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74A44-DF31-4C6F-98F6-FAE6342637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0360" y="2940120"/>
            <a:ext cx="365112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464360" y="2940120"/>
            <a:ext cx="365112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298360" y="2940120"/>
            <a:ext cx="365112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0360" y="7283520"/>
            <a:ext cx="365112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464360" y="7283520"/>
            <a:ext cx="365112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298360" y="7283520"/>
            <a:ext cx="365112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7DF6F-2D72-4C29-9770-E7C2B411D8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0360" y="2940120"/>
            <a:ext cx="11339280" cy="831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250"/>
              </a:spcBef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C74E07-8DEA-43EF-A41F-9A67A0E186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0360" y="2940120"/>
            <a:ext cx="11339280" cy="83152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284DC-3CFF-421F-8121-4CB8960658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0360" y="2940120"/>
            <a:ext cx="5533560" cy="83152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441120" y="2940120"/>
            <a:ext cx="5533560" cy="83152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288EA7-B7BA-496C-AAD1-4112134838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E10A0-CCFE-4A28-B54A-8DF13CA289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0360" y="504720"/>
            <a:ext cx="11339280" cy="973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250"/>
              </a:spcBef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0DC9A-9B17-441F-AAD3-594F5B0E81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0360" y="29401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441120" y="2940120"/>
            <a:ext cx="5533560" cy="83152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0360" y="72835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2DEDA3-38FD-401B-8EB5-7AC8C31E94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0360" y="2940120"/>
            <a:ext cx="5533560" cy="83152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441120" y="29401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441120" y="72835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26A775-CB6F-4833-A136-B80A704E2F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0360" y="29401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441120" y="2940120"/>
            <a:ext cx="553356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0360" y="7283520"/>
            <a:ext cx="11339280" cy="396612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EC3EB-D697-4D65-8F5F-8712F7E08D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0360" y="504720"/>
            <a:ext cx="11339280" cy="210024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6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0360" y="2940120"/>
            <a:ext cx="11339280" cy="83152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marL="539640" indent="-539640"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1" marL="1170000" indent="-449280">
              <a:spcBef>
                <a:spcPts val="1250"/>
              </a:spcBef>
              <a:buClr>
                <a:srgbClr val="000000"/>
              </a:buClr>
              <a:buFont typeface="Arial"/>
              <a:buChar char="–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2" marL="1798560" indent="-358560"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3" marL="2519280" indent="-358560">
              <a:spcBef>
                <a:spcPts val="1250"/>
              </a:spcBef>
              <a:buClr>
                <a:srgbClr val="000000"/>
              </a:buClr>
              <a:buFont typeface="Arial"/>
              <a:buChar char="–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4" marL="3238560" indent="-358920">
              <a:spcBef>
                <a:spcPts val="1250"/>
              </a:spcBef>
              <a:buClr>
                <a:srgbClr val="000000"/>
              </a:buClr>
              <a:buFont typeface="Arial"/>
              <a:buChar char="»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5" marL="3238560" indent="-358920">
              <a:spcBef>
                <a:spcPts val="1250"/>
              </a:spcBef>
              <a:buClr>
                <a:srgbClr val="000000"/>
              </a:buClr>
              <a:buFont typeface="Arial"/>
              <a:buChar char="»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6" marL="3238560" indent="-358920">
              <a:spcBef>
                <a:spcPts val="1250"/>
              </a:spcBef>
              <a:buClr>
                <a:srgbClr val="000000"/>
              </a:buClr>
              <a:buFont typeface="Arial"/>
              <a:buChar char="»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0360" y="11677320"/>
            <a:ext cx="2939760" cy="67140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lstStyle>
            <a:lvl1pPr indent="0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305240" y="11677320"/>
            <a:ext cx="3989520" cy="67140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029880" y="11677320"/>
            <a:ext cx="2939760" cy="67140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lstStyle>
            <a:lvl1pPr indent="0" algn="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fld id="{F42132CA-B865-42D1-8C5E-B52358846119}" type="slidenum">
              <a:rPr b="0" lang="en-US" sz="1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7480440" y="8894880"/>
            <a:ext cx="5126040" cy="3468600"/>
          </a:xfrm>
          <a:prstGeom prst="rect">
            <a:avLst/>
          </a:prstGeom>
          <a:ln w="0">
            <a:noFill/>
          </a:ln>
        </p:spPr>
      </p:pic>
      <p:pic>
        <p:nvPicPr>
          <p:cNvPr id="42" name="Chart 4" descr=""/>
          <p:cNvPicPr/>
          <p:nvPr/>
        </p:nvPicPr>
        <p:blipFill>
          <a:blip r:embed="rId2"/>
          <a:stretch/>
        </p:blipFill>
        <p:spPr>
          <a:xfrm>
            <a:off x="7480440" y="701640"/>
            <a:ext cx="5126040" cy="3535560"/>
          </a:xfrm>
          <a:prstGeom prst="rect">
            <a:avLst/>
          </a:prstGeom>
          <a:ln w="0">
            <a:noFill/>
          </a:ln>
        </p:spPr>
      </p:pic>
      <p:pic>
        <p:nvPicPr>
          <p:cNvPr id="43" name="Chart 5" descr=""/>
          <p:cNvPicPr/>
          <p:nvPr/>
        </p:nvPicPr>
        <p:blipFill>
          <a:blip r:embed="rId3"/>
          <a:stretch/>
        </p:blipFill>
        <p:spPr>
          <a:xfrm>
            <a:off x="7461360" y="4724280"/>
            <a:ext cx="5145120" cy="35658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" descr=""/>
          <p:cNvPicPr/>
          <p:nvPr/>
        </p:nvPicPr>
        <p:blipFill>
          <a:blip r:embed="rId4"/>
          <a:srcRect l="4650" t="0" r="6175" b="0"/>
          <a:stretch/>
        </p:blipFill>
        <p:spPr>
          <a:xfrm>
            <a:off x="3276720" y="631800"/>
            <a:ext cx="3757320" cy="35989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7" descr=""/>
          <p:cNvPicPr/>
          <p:nvPr/>
        </p:nvPicPr>
        <p:blipFill>
          <a:blip r:embed="rId5"/>
          <a:srcRect l="0" t="0" r="-19" b="0"/>
          <a:stretch/>
        </p:blipFill>
        <p:spPr>
          <a:xfrm>
            <a:off x="3784680" y="4695840"/>
            <a:ext cx="3078000" cy="36003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8" descr=""/>
          <p:cNvPicPr/>
          <p:nvPr/>
        </p:nvPicPr>
        <p:blipFill>
          <a:blip r:embed="rId6"/>
          <a:stretch/>
        </p:blipFill>
        <p:spPr>
          <a:xfrm>
            <a:off x="460440" y="4695840"/>
            <a:ext cx="3051000" cy="3600360"/>
          </a:xfrm>
          <a:prstGeom prst="rect">
            <a:avLst/>
          </a:prstGeom>
          <a:ln w="0">
            <a:noFill/>
          </a:ln>
        </p:spPr>
      </p:pic>
      <p:sp>
        <p:nvSpPr>
          <p:cNvPr id="47" name="TextBox 9"/>
          <p:cNvSpPr/>
          <p:nvPr/>
        </p:nvSpPr>
        <p:spPr>
          <a:xfrm>
            <a:off x="1579680" y="190440"/>
            <a:ext cx="9480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aseline Ventral Rostral Putamen Connectivity Correlated to Treatment Respons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507960" y="471492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Z+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476640" y="636480"/>
            <a:ext cx="45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Z-4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3061800" y="395460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R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3"/>
          <p:cNvSpPr/>
          <p:nvPr/>
        </p:nvSpPr>
        <p:spPr>
          <a:xfrm>
            <a:off x="3564720" y="4714920"/>
            <a:ext cx="49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Z-2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1585800" y="4248000"/>
            <a:ext cx="9480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aseline Medial Dorsal Thalamus Connectivity Correlated to Treatment Respons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14760" y="650880"/>
            <a:ext cx="416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5671080" y="509760"/>
            <a:ext cx="416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7"/>
          <p:cNvSpPr/>
          <p:nvPr/>
        </p:nvSpPr>
        <p:spPr>
          <a:xfrm>
            <a:off x="37440" y="473076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3616920" y="63648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X-8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9"/>
          <p:cNvSpPr/>
          <p:nvPr/>
        </p:nvSpPr>
        <p:spPr>
          <a:xfrm>
            <a:off x="8659440" y="638280"/>
            <a:ext cx="270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RP-DMPFC Functional Connectivit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8589240" y="4665600"/>
            <a:ext cx="284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halamus-OFC Functional Connectivit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6728040" y="8010360"/>
            <a:ext cx="37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R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1585800" y="8321760"/>
            <a:ext cx="9480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aseline Subthalamic Nucleus Connectivity Correlated to Treatment Respons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23" descr=""/>
          <p:cNvPicPr/>
          <p:nvPr/>
        </p:nvPicPr>
        <p:blipFill>
          <a:blip r:embed="rId7"/>
          <a:srcRect l="8526" t="0" r="8082" b="0"/>
          <a:stretch/>
        </p:blipFill>
        <p:spPr>
          <a:xfrm>
            <a:off x="457200" y="8764560"/>
            <a:ext cx="2903400" cy="3600360"/>
          </a:xfrm>
          <a:prstGeom prst="rect">
            <a:avLst/>
          </a:prstGeom>
          <a:ln w="0">
            <a:noFill/>
          </a:ln>
        </p:spPr>
      </p:pic>
      <p:sp>
        <p:nvSpPr>
          <p:cNvPr id="62" name="TextBox 24"/>
          <p:cNvSpPr/>
          <p:nvPr/>
        </p:nvSpPr>
        <p:spPr>
          <a:xfrm>
            <a:off x="492120" y="8766000"/>
            <a:ext cx="58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Z-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Picture 25" descr=""/>
          <p:cNvPicPr/>
          <p:nvPr/>
        </p:nvPicPr>
        <p:blipFill>
          <a:blip r:embed="rId8"/>
          <a:stretch/>
        </p:blipFill>
        <p:spPr>
          <a:xfrm>
            <a:off x="3798720" y="8767800"/>
            <a:ext cx="3235320" cy="3600360"/>
          </a:xfrm>
          <a:prstGeom prst="rect">
            <a:avLst/>
          </a:prstGeom>
          <a:ln w="0">
            <a:noFill/>
          </a:ln>
        </p:spPr>
      </p:pic>
      <p:sp>
        <p:nvSpPr>
          <p:cNvPr id="64" name="Rectangle 26"/>
          <p:cNvSpPr/>
          <p:nvPr/>
        </p:nvSpPr>
        <p:spPr>
          <a:xfrm>
            <a:off x="3354480" y="8767800"/>
            <a:ext cx="444240" cy="3600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7"/>
          <p:cNvSpPr/>
          <p:nvPr/>
        </p:nvSpPr>
        <p:spPr>
          <a:xfrm>
            <a:off x="6707160" y="12101400"/>
            <a:ext cx="42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R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8"/>
          <p:cNvSpPr/>
          <p:nvPr/>
        </p:nvSpPr>
        <p:spPr>
          <a:xfrm>
            <a:off x="3560760" y="8771040"/>
            <a:ext cx="75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Z+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9"/>
          <p:cNvSpPr/>
          <p:nvPr/>
        </p:nvSpPr>
        <p:spPr>
          <a:xfrm>
            <a:off x="23400" y="8767800"/>
            <a:ext cx="416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0"/>
          <p:cNvSpPr/>
          <p:nvPr/>
        </p:nvSpPr>
        <p:spPr>
          <a:xfrm>
            <a:off x="7056360" y="8764560"/>
            <a:ext cx="3970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8606160" y="8755200"/>
            <a:ext cx="28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TN-Thalamus Functional Connectivit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32"/>
          <p:cNvSpPr/>
          <p:nvPr/>
        </p:nvSpPr>
        <p:spPr>
          <a:xfrm>
            <a:off x="3478320" y="4695840"/>
            <a:ext cx="320400" cy="3600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3"/>
          <p:cNvSpPr/>
          <p:nvPr/>
        </p:nvSpPr>
        <p:spPr>
          <a:xfrm>
            <a:off x="3562560" y="4695840"/>
            <a:ext cx="49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Z-2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34"/>
          <p:cNvSpPr/>
          <p:nvPr/>
        </p:nvSpPr>
        <p:spPr>
          <a:xfrm>
            <a:off x="6765840" y="4695840"/>
            <a:ext cx="268200" cy="3600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5"/>
          <p:cNvSpPr/>
          <p:nvPr/>
        </p:nvSpPr>
        <p:spPr>
          <a:xfrm>
            <a:off x="6689160" y="801036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R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6"/>
          <p:cNvSpPr/>
          <p:nvPr/>
        </p:nvSpPr>
        <p:spPr>
          <a:xfrm>
            <a:off x="7055640" y="469584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7"/>
          <p:cNvSpPr/>
          <p:nvPr/>
        </p:nvSpPr>
        <p:spPr>
          <a:xfrm>
            <a:off x="7061040" y="627120"/>
            <a:ext cx="416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8"/>
          <p:cNvSpPr/>
          <p:nvPr/>
        </p:nvSpPr>
        <p:spPr>
          <a:xfrm>
            <a:off x="9406800" y="968400"/>
            <a:ext cx="56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9"/>
          <p:cNvSpPr/>
          <p:nvPr/>
        </p:nvSpPr>
        <p:spPr>
          <a:xfrm>
            <a:off x="10819080" y="868320"/>
            <a:ext cx="56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0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40"/>
          <p:cNvSpPr/>
          <p:nvPr/>
        </p:nvSpPr>
        <p:spPr>
          <a:xfrm>
            <a:off x="10782360" y="4943520"/>
            <a:ext cx="56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1"/>
          <p:cNvSpPr/>
          <p:nvPr/>
        </p:nvSpPr>
        <p:spPr>
          <a:xfrm>
            <a:off x="10815120" y="9245520"/>
            <a:ext cx="56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0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0" name="Group 42"/>
          <p:cNvGrpSpPr/>
          <p:nvPr/>
        </p:nvGrpSpPr>
        <p:grpSpPr>
          <a:xfrm>
            <a:off x="450720" y="633240"/>
            <a:ext cx="3048120" cy="3600720"/>
            <a:chOff x="450720" y="633240"/>
            <a:chExt cx="3048120" cy="3600720"/>
          </a:xfrm>
        </p:grpSpPr>
        <p:pic>
          <p:nvPicPr>
            <p:cNvPr id="81" name="Picture 43" descr=""/>
            <p:cNvPicPr/>
            <p:nvPr/>
          </p:nvPicPr>
          <p:blipFill>
            <a:blip r:embed="rId9"/>
            <a:stretch/>
          </p:blipFill>
          <p:spPr>
            <a:xfrm>
              <a:off x="450720" y="633240"/>
              <a:ext cx="3048120" cy="360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Rectangle 44"/>
            <p:cNvSpPr/>
            <p:nvPr/>
          </p:nvSpPr>
          <p:spPr>
            <a:xfrm>
              <a:off x="1632600" y="1930680"/>
              <a:ext cx="124560" cy="120240"/>
            </a:xfrm>
            <a:prstGeom prst="rect">
              <a:avLst/>
            </a:prstGeom>
            <a:solidFill>
              <a:srgbClr val="0ffd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719280"/>
                  <a:tab algn="l" pos="1438200"/>
                  <a:tab algn="l" pos="2157480"/>
                  <a:tab algn="l" pos="2876400"/>
                  <a:tab algn="l" pos="3595680"/>
                  <a:tab algn="l" pos="4314960"/>
                  <a:tab algn="l" pos="5033880"/>
                  <a:tab algn="l" pos="5753160"/>
                  <a:tab algn="l" pos="6472080"/>
                  <a:tab algn="l" pos="7191360"/>
                  <a:tab algn="l" pos="7910640"/>
                  <a:tab algn="l" pos="8629560"/>
                  <a:tab algn="l" pos="9348840"/>
                  <a:tab algn="l" pos="10067760"/>
                  <a:tab algn="l" pos="1078704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45"/>
            <p:cNvSpPr/>
            <p:nvPr/>
          </p:nvSpPr>
          <p:spPr>
            <a:xfrm>
              <a:off x="2298960" y="1930680"/>
              <a:ext cx="124560" cy="120240"/>
            </a:xfrm>
            <a:prstGeom prst="rect">
              <a:avLst/>
            </a:prstGeom>
            <a:solidFill>
              <a:srgbClr val="0ffd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719280"/>
                  <a:tab algn="l" pos="1438200"/>
                  <a:tab algn="l" pos="2157480"/>
                  <a:tab algn="l" pos="2876400"/>
                  <a:tab algn="l" pos="3595680"/>
                  <a:tab algn="l" pos="4314960"/>
                  <a:tab algn="l" pos="5033880"/>
                  <a:tab algn="l" pos="5753160"/>
                  <a:tab algn="l" pos="6472080"/>
                  <a:tab algn="l" pos="7191360"/>
                  <a:tab algn="l" pos="7910640"/>
                  <a:tab algn="l" pos="8629560"/>
                  <a:tab algn="l" pos="9348840"/>
                  <a:tab algn="l" pos="10067760"/>
                  <a:tab algn="l" pos="1078704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03T18:10:09Z</dcterms:created>
  <dc:creator>Katie Dunlop</dc:creator>
  <dc:description/>
  <dc:language>en-US</dc:language>
  <cp:lastModifiedBy>Satish.d</cp:lastModifiedBy>
  <dcterms:modified xsi:type="dcterms:W3CDTF">2015-10-20T14:23:54Z</dcterms:modified>
  <cp:revision>2</cp:revision>
  <dc:subject/>
  <dc:title>PowerPoint Presentation</dc:title>
</cp:coreProperties>
</file>